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41DDA-8A08-4432-B8A3-FD99E48B93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7C769-AC38-40D9-8F67-A75A120359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27E4B-4700-4D04-BC88-2B7A4437E9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B1FF3-6791-4100-9468-350B1A8417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CDA00-9A35-4B55-A388-549BDD3E4D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84405C-B1F6-47DC-8AF6-7FD5B5D629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BEA9E-3E3A-4FB2-8E62-F5B732FC9D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A3CEF-05E3-4391-A82C-FF84BADC75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F752D-5641-417E-9F7D-A11944C3BB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A49A2-5B46-462A-9753-221B8B873E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CFA17-DE9F-4133-B8BA-CA405312C3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D1E69-8328-45E1-A746-5665F0907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3F9E76-84A1-4924-BC89-93D5BD290990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272880" y="250920"/>
            <a:ext cx="257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굴림"/>
              </a:rPr>
              <a:t>Supplemental Figures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115920" y="3780000"/>
            <a:ext cx="66261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upplemental Figure 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Express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IAA29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hos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mutant calli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eaf explants from the third and fourth leaves of 2-week-old plants were incubated on CIM for 7 days. Whole leaf explants with developing calli were harvested for total RNA isolation. Transcript accumulation was analyzed by RT-PCR. The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TUB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gene was used as an internal control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43" name="그룹 1"/>
          <p:cNvGrpSpPr/>
          <p:nvPr/>
        </p:nvGrpSpPr>
        <p:grpSpPr>
          <a:xfrm>
            <a:off x="2322360" y="2533680"/>
            <a:ext cx="2171880" cy="1095480"/>
            <a:chOff x="2322360" y="2533680"/>
            <a:chExt cx="2171880" cy="1095480"/>
          </a:xfrm>
        </p:grpSpPr>
        <p:pic>
          <p:nvPicPr>
            <p:cNvPr id="44" name="그림 5" descr=""/>
            <p:cNvPicPr/>
            <p:nvPr/>
          </p:nvPicPr>
          <p:blipFill>
            <a:blip r:embed="rId1"/>
            <a:stretch/>
          </p:blipFill>
          <p:spPr>
            <a:xfrm>
              <a:off x="2646360" y="3197520"/>
              <a:ext cx="184788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5" name="Rectangle 51"/>
            <p:cNvSpPr/>
            <p:nvPr/>
          </p:nvSpPr>
          <p:spPr>
            <a:xfrm>
              <a:off x="2398680" y="3353040"/>
              <a:ext cx="20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TUB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" name="Rectangle 51"/>
            <p:cNvSpPr/>
            <p:nvPr/>
          </p:nvSpPr>
          <p:spPr>
            <a:xfrm>
              <a:off x="2849400" y="2533680"/>
              <a:ext cx="243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ol-0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" name="Rectangle 51"/>
            <p:cNvSpPr/>
            <p:nvPr/>
          </p:nvSpPr>
          <p:spPr>
            <a:xfrm>
              <a:off x="3448440" y="25336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os1-3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" name="Rectangle 51"/>
            <p:cNvSpPr/>
            <p:nvPr/>
          </p:nvSpPr>
          <p:spPr>
            <a:xfrm>
              <a:off x="4029480" y="25336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os1-5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pic>
          <p:nvPicPr>
            <p:cNvPr id="49" name="그림 11" descr=""/>
            <p:cNvPicPr/>
            <p:nvPr/>
          </p:nvPicPr>
          <p:blipFill>
            <a:blip r:embed="rId2"/>
            <a:stretch/>
          </p:blipFill>
          <p:spPr>
            <a:xfrm>
              <a:off x="2643120" y="2702520"/>
              <a:ext cx="1846440" cy="431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0" name="Rectangle 51"/>
            <p:cNvSpPr/>
            <p:nvPr/>
          </p:nvSpPr>
          <p:spPr>
            <a:xfrm>
              <a:off x="2322360" y="2856240"/>
              <a:ext cx="279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IAA29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25T06:24:20Z</dcterms:created>
  <dc:creator>이경희</dc:creator>
  <dc:description/>
  <dc:language>en-US</dc:language>
  <cp:lastModifiedBy>Pil Joon Seo</cp:lastModifiedBy>
  <dcterms:modified xsi:type="dcterms:W3CDTF">2023-09-16T23:26:33Z</dcterms:modified>
  <cp:revision>249</cp:revision>
  <dc:subject/>
  <dc:title>PowerPoint 프레젠테이션</dc:title>
</cp:coreProperties>
</file>